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704" userDrawn="1">
          <p15:clr>
            <a:srgbClr val="A4A3A4"/>
          </p15:clr>
        </p15:guide>
        <p15:guide id="2" orient="horz" pos="187" userDrawn="1">
          <p15:clr>
            <a:srgbClr val="A4A3A4"/>
          </p15:clr>
        </p15:guide>
        <p15:guide id="3" orient="horz" pos="646">
          <p15:clr>
            <a:srgbClr val="A4A3A4"/>
          </p15:clr>
        </p15:guide>
        <p15:guide id="4" pos="8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4" autoAdjust="0"/>
    <p:restoredTop sz="94249" autoAdjust="0"/>
  </p:normalViewPr>
  <p:slideViewPr>
    <p:cSldViewPr snapToGrid="0">
      <p:cViewPr varScale="1">
        <p:scale>
          <a:sx n="115" d="100"/>
          <a:sy n="115" d="100"/>
        </p:scale>
        <p:origin x="318" y="84"/>
      </p:cViewPr>
      <p:guideLst>
        <p:guide pos="3704"/>
        <p:guide orient="horz" pos="187"/>
        <p:guide orient="horz" pos="646"/>
        <p:guide pos="8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F11EB8-B595-4FB6-80E7-6BF0A2D2575C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0C6A6E-6319-4E23-B8B5-63752D1FD049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87835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DA1F02E-E804-4BFF-87A1-A925966D52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06A80D0-F7B8-4BE3-8878-4B4D0F9730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BC92B3B-C4E4-44F0-8873-892C2E11E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B1352D5-D034-44E1-A984-3A9EC0FF5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DF21B10-D5C7-4A94-BCE8-9BFD64869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7487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622B8D-50D0-4217-9C14-8EAD817959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8B059E0-F680-45F9-8391-A36351172E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A1A5C34-EFFF-48A2-9188-E7ACF0801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2E6C531-106C-450C-9081-AB454B295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937426-E518-4D17-9C15-CF29EFA6B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2963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753D7AB-E991-4DD9-A2EC-2C4A621D77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1B47462-A05F-43C1-B076-1110474221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FE98B80-AAB2-41C6-889B-9406DA474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E3AD78-C6A9-45DD-8D0C-D69D1FCB7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94ADC8E-EFAA-44F3-B835-8F4E8DE39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3633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AAB079-C5F9-41C5-A888-4A7662922D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9C2497E-5741-4924-BA72-08376E4480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6FBF242-E158-477E-95C0-ECD4C1E25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BC3D811-F5B7-4A6C-B0D7-CD0C7415F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120306-FEAA-4E6C-A74C-2A55EFC88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941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9B09A57-8C16-4201-BA9F-2AAC1DC7DD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86F04DC-1069-4224-B514-441211B095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873BFC-B5FD-4DEF-8920-C804D2B40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2E8A52-5866-4772-8326-2B083EAE2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311FE5F-7ADD-428A-9D47-C33968553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7213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1DA805-4E1B-44F4-B972-8F18419B13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3319FAD-F6FB-4073-9C1C-E2DCE09E8E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753F863-DCE3-42FE-956B-169B6A13B7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A13051D-CB70-4D27-91E8-B16A1A8019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93D55F9-8705-402E-9165-78013A1FC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7506ECC-DAFF-4AC3-99B6-B02129546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62252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2DBD193-7DB4-4492-A501-E85FB6B3FE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A614A54-EE43-47A2-B5E7-11A6836B17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C022BA0-F98D-4656-9E73-DFC75CB8ED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F5739B4-B72D-4565-9ECB-1FB0E8980C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1BB2B603-73F8-4060-9DAF-03E97F4ADF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BD5DCEE-38F5-44DF-B4C0-0C7D73261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C249D05-22A3-4B5E-80FE-44023A57F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CCAF48C-8111-4A2E-B28A-2FCBAD8D5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6702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448F28-180A-4E04-AEEF-947C7FF695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F19BE54-E3C8-4273-868B-B78FF9681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C597D61-CDA8-4057-969E-D2E541293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D31A025-DB3E-4BFD-B1D0-EBB7B3407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3905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E691FE1-F4AB-4D93-9EC2-8D26B0604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1EB40EF-6FA9-4472-B881-9376950AC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CA6EB2B-1175-4ABF-B627-0812E8E66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8200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1C87181-6691-4EC2-83CF-324F5E1B2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84EB133-AA26-447E-9FF0-C08812EF13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6A7343C-5FB7-4DA6-9A3D-DD1317EADA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30BEDA6-DAE4-445E-9C05-291C9211D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0348C74-D065-4720-8BE1-A6CDFB1E4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16CB20A-1D1F-4351-9E8C-A9E0634B6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09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11F2196-BF1E-4585-B1B1-7362830D87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A5913D7-3EAF-44AD-A674-E5DD629EC5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DF438D7-2E3C-468C-961F-E34E748174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E9B97EB-42E6-43A9-8F5A-A52392B47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31766E5-0A2E-4CA8-ACE7-165A7C10B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96FECF2-E85A-40F6-BF45-1142AD861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3438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03406A5-4E70-4A86-B197-2ECA27A800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04C0639-1EE8-4BD1-81E3-1AA86AA268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07BB379-D162-46E9-8031-74BD0ECDA2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2AB1C-9004-43ED-8D5F-8293CC34AEA5}" type="datetimeFigureOut">
              <a:rPr lang="it-IT" smtClean="0"/>
              <a:pPr/>
              <a:t>23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1FB133C-5995-4397-AF56-EF4A6B246A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AD3A64B-D9D3-407B-8E0E-3F86048B9A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3AF70-58E3-42E5-A01D-8E7B8BE14A7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3352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o 13">
            <a:extLst>
              <a:ext uri="{FF2B5EF4-FFF2-40B4-BE49-F238E27FC236}">
                <a16:creationId xmlns:a16="http://schemas.microsoft.com/office/drawing/2014/main" id="{74AA1429-A945-4211-A254-3245F3EA51A9}"/>
              </a:ext>
            </a:extLst>
          </p:cNvPr>
          <p:cNvGrpSpPr>
            <a:grpSpLocks noChangeAspect="1"/>
          </p:cNvGrpSpPr>
          <p:nvPr/>
        </p:nvGrpSpPr>
        <p:grpSpPr>
          <a:xfrm>
            <a:off x="1275909" y="699796"/>
            <a:ext cx="4060719" cy="2839160"/>
            <a:chOff x="2837145" y="3792539"/>
            <a:chExt cx="3894281" cy="2722699"/>
          </a:xfrm>
        </p:grpSpPr>
        <p:graphicFrame>
          <p:nvGraphicFramePr>
            <p:cNvPr id="5" name="Oggetto 4">
              <a:extLst>
                <a:ext uri="{FF2B5EF4-FFF2-40B4-BE49-F238E27FC236}">
                  <a16:creationId xmlns:a16="http://schemas.microsoft.com/office/drawing/2014/main" id="{10D15E08-473C-4E19-AA89-67413470178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6368260"/>
                </p:ext>
              </p:extLst>
            </p:nvPr>
          </p:nvGraphicFramePr>
          <p:xfrm>
            <a:off x="2893033" y="3792539"/>
            <a:ext cx="3838393" cy="26277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683" name="Prism 8" r:id="rId3" imgW="3590553" imgH="2463814" progId="">
                    <p:embed/>
                  </p:oleObj>
                </mc:Choice>
                <mc:Fallback>
                  <p:oleObj name="Prism 8" r:id="rId3" imgW="3590553" imgH="2463814" progId="">
                    <p:embed/>
                    <p:pic>
                      <p:nvPicPr>
                        <p:cNvPr id="0" name="Picture 33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93033" y="3792539"/>
                          <a:ext cx="3838393" cy="2627731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30C189A5-58E8-409D-AA8F-91FBCE3D7F0E}"/>
                </a:ext>
              </a:extLst>
            </p:cNvPr>
            <p:cNvSpPr txBox="1"/>
            <p:nvPr/>
          </p:nvSpPr>
          <p:spPr>
            <a:xfrm rot="16200000">
              <a:off x="2132959" y="4940919"/>
              <a:ext cx="1674017" cy="2656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1CCF33FF-2699-4B2E-8F78-4A4795AA2F49}"/>
                </a:ext>
              </a:extLst>
            </p:cNvPr>
            <p:cNvSpPr txBox="1"/>
            <p:nvPr/>
          </p:nvSpPr>
          <p:spPr>
            <a:xfrm>
              <a:off x="3351144" y="6249601"/>
              <a:ext cx="2939309" cy="26563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9C84D4C2-3A1D-405C-9AD9-17E2B088236D}"/>
              </a:ext>
            </a:extLst>
          </p:cNvPr>
          <p:cNvSpPr txBox="1"/>
          <p:nvPr/>
        </p:nvSpPr>
        <p:spPr>
          <a:xfrm>
            <a:off x="1176342" y="735342"/>
            <a:ext cx="3815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092569B7-D00F-415D-9D9A-73BC940E0479}"/>
              </a:ext>
            </a:extLst>
          </p:cNvPr>
          <p:cNvSpPr txBox="1"/>
          <p:nvPr/>
        </p:nvSpPr>
        <p:spPr>
          <a:xfrm>
            <a:off x="5542302" y="743822"/>
            <a:ext cx="4828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95E64411-E5BA-4988-88B3-357137E1A00B}"/>
              </a:ext>
            </a:extLst>
          </p:cNvPr>
          <p:cNvSpPr txBox="1"/>
          <p:nvPr/>
        </p:nvSpPr>
        <p:spPr>
          <a:xfrm>
            <a:off x="8469438" y="6472626"/>
            <a:ext cx="2656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dirty="0" err="1" smtClean="0"/>
              <a:t>Supplementary</a:t>
            </a:r>
            <a:r>
              <a:rPr lang="it-IT" dirty="0" smtClean="0"/>
              <a:t> </a:t>
            </a:r>
            <a:r>
              <a:rPr lang="it-IT" dirty="0"/>
              <a:t>Figure 2</a:t>
            </a:r>
          </a:p>
        </p:txBody>
      </p:sp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47FFC1BB-2B3C-48D7-918A-853B00AAC3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7098043"/>
              </p:ext>
            </p:extLst>
          </p:nvPr>
        </p:nvGraphicFramePr>
        <p:xfrm>
          <a:off x="5891752" y="693740"/>
          <a:ext cx="3994150" cy="2744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684" name="Prism 8" r:id="rId5" imgW="3590553" imgH="2463814" progId="">
                  <p:embed/>
                </p:oleObj>
              </mc:Choice>
              <mc:Fallback>
                <p:oleObj name="Prism 8" r:id="rId5" imgW="3590553" imgH="2463814" progId="">
                  <p:embed/>
                  <p:pic>
                    <p:nvPicPr>
                      <p:cNvPr id="0" name="Picture 33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891752" y="693740"/>
                        <a:ext cx="3994150" cy="27447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A2B6E29B-1392-4E09-A450-562E95BD4C77}"/>
              </a:ext>
            </a:extLst>
          </p:cNvPr>
          <p:cNvSpPr txBox="1"/>
          <p:nvPr/>
        </p:nvSpPr>
        <p:spPr>
          <a:xfrm rot="16200000">
            <a:off x="5104235" y="1901870"/>
            <a:ext cx="1723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 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C1A0DEC6-EB95-4896-A7CA-AC23C56EE8C8}"/>
              </a:ext>
            </a:extLst>
          </p:cNvPr>
          <p:cNvSpPr txBox="1"/>
          <p:nvPr/>
        </p:nvSpPr>
        <p:spPr>
          <a:xfrm>
            <a:off x="6392334" y="3281388"/>
            <a:ext cx="305046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5D7DE14-2E8C-4024-9BCC-7182DE09D6CD}"/>
              </a:ext>
            </a:extLst>
          </p:cNvPr>
          <p:cNvSpPr txBox="1"/>
          <p:nvPr/>
        </p:nvSpPr>
        <p:spPr>
          <a:xfrm>
            <a:off x="1205948" y="3700182"/>
            <a:ext cx="3857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4" name="Gruppo 23"/>
          <p:cNvGrpSpPr/>
          <p:nvPr/>
        </p:nvGrpSpPr>
        <p:grpSpPr>
          <a:xfrm>
            <a:off x="1307753" y="3699920"/>
            <a:ext cx="3989744" cy="2595227"/>
            <a:chOff x="1079144" y="4038600"/>
            <a:chExt cx="3989744" cy="2595227"/>
          </a:xfrm>
        </p:grpSpPr>
        <p:graphicFrame>
          <p:nvGraphicFramePr>
            <p:cNvPr id="12" name="Oggetto 11">
              <a:extLst>
                <a:ext uri="{FF2B5EF4-FFF2-40B4-BE49-F238E27FC236}">
                  <a16:creationId xmlns:a16="http://schemas.microsoft.com/office/drawing/2014/main" id="{C064612F-9BDF-4BD6-A2BC-241EB3C390B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76964026"/>
                </p:ext>
              </p:extLst>
            </p:nvPr>
          </p:nvGraphicFramePr>
          <p:xfrm>
            <a:off x="1168400" y="4038600"/>
            <a:ext cx="3900488" cy="24685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685" name="Prism 8" r:id="rId7" imgW="3892347" imgH="2463814" progId="">
                    <p:embed/>
                  </p:oleObj>
                </mc:Choice>
                <mc:Fallback>
                  <p:oleObj name="Prism 8" r:id="rId7" imgW="3892347" imgH="2463814" progId="">
                    <p:embed/>
                    <p:pic>
                      <p:nvPicPr>
                        <p:cNvPr id="0" name="Picture 33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68400" y="4038600"/>
                          <a:ext cx="3900488" cy="2468563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AA223219-36E3-4D54-BA06-36E178F1E5F5}"/>
                </a:ext>
              </a:extLst>
            </p:cNvPr>
            <p:cNvSpPr txBox="1"/>
            <p:nvPr/>
          </p:nvSpPr>
          <p:spPr>
            <a:xfrm>
              <a:off x="1591734" y="6356828"/>
              <a:ext cx="280246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8A3D11EC-56B8-414C-8CA8-0F3162F1D3FC}"/>
                </a:ext>
              </a:extLst>
            </p:cNvPr>
            <p:cNvSpPr txBox="1"/>
            <p:nvPr/>
          </p:nvSpPr>
          <p:spPr>
            <a:xfrm rot="16200000">
              <a:off x="331834" y="5114021"/>
              <a:ext cx="1771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73C8D2D1-DB94-4EE1-BDA3-4C9401D1690F}"/>
              </a:ext>
            </a:extLst>
          </p:cNvPr>
          <p:cNvSpPr txBox="1"/>
          <p:nvPr/>
        </p:nvSpPr>
        <p:spPr>
          <a:xfrm>
            <a:off x="5552221" y="3711014"/>
            <a:ext cx="4083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3" name="Gruppo 22"/>
          <p:cNvGrpSpPr/>
          <p:nvPr/>
        </p:nvGrpSpPr>
        <p:grpSpPr>
          <a:xfrm>
            <a:off x="5839505" y="3721087"/>
            <a:ext cx="4310436" cy="2592156"/>
            <a:chOff x="5974977" y="3949696"/>
            <a:chExt cx="4310436" cy="2592156"/>
          </a:xfrm>
        </p:grpSpPr>
        <p:graphicFrame>
          <p:nvGraphicFramePr>
            <p:cNvPr id="19" name="Oggetto 18">
              <a:extLst>
                <a:ext uri="{FF2B5EF4-FFF2-40B4-BE49-F238E27FC236}">
                  <a16:creationId xmlns:a16="http://schemas.microsoft.com/office/drawing/2014/main" id="{AC118426-C1A5-401E-ADF0-D872CEFD2D5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37644130"/>
                </p:ext>
              </p:extLst>
            </p:nvPr>
          </p:nvGraphicFramePr>
          <p:xfrm>
            <a:off x="6070600" y="3949696"/>
            <a:ext cx="4214813" cy="24685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686" name="Prism 8" r:id="rId9" imgW="4194141" imgH="2463814" progId="">
                    <p:embed/>
                  </p:oleObj>
                </mc:Choice>
                <mc:Fallback>
                  <p:oleObj name="Prism 8" r:id="rId9" imgW="4194141" imgH="2463814" progId="">
                    <p:embed/>
                    <p:pic>
                      <p:nvPicPr>
                        <p:cNvPr id="0" name="Picture 33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070600" y="3949696"/>
                          <a:ext cx="4214813" cy="2468563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90006594-AFC2-4513-8CA4-5C94E8CBC63D}"/>
                </a:ext>
              </a:extLst>
            </p:cNvPr>
            <p:cNvSpPr txBox="1"/>
            <p:nvPr/>
          </p:nvSpPr>
          <p:spPr>
            <a:xfrm rot="16200000">
              <a:off x="5251823" y="5125198"/>
              <a:ext cx="1723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2FB436D7-A051-484C-AA84-ECE133EB6E8A}"/>
                </a:ext>
              </a:extLst>
            </p:cNvPr>
            <p:cNvSpPr txBox="1"/>
            <p:nvPr/>
          </p:nvSpPr>
          <p:spPr>
            <a:xfrm>
              <a:off x="6493934" y="6264853"/>
              <a:ext cx="283633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562311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71</TotalTime>
  <Words>3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8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 Baldoni</dc:creator>
  <cp:lastModifiedBy>Reparto</cp:lastModifiedBy>
  <cp:revision>240</cp:revision>
  <dcterms:created xsi:type="dcterms:W3CDTF">2020-06-05T10:58:17Z</dcterms:created>
  <dcterms:modified xsi:type="dcterms:W3CDTF">2021-03-23T14:35:17Z</dcterms:modified>
</cp:coreProperties>
</file>